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F81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1" autoAdjust="0"/>
    <p:restoredTop sz="90360" autoAdjust="0"/>
  </p:normalViewPr>
  <p:slideViewPr>
    <p:cSldViewPr>
      <p:cViewPr varScale="1">
        <p:scale>
          <a:sx n="105" d="100"/>
          <a:sy n="105" d="100"/>
        </p:scale>
        <p:origin x="107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0.2165639876237527"/>
          <c:y val="0.36158573928258969"/>
          <c:w val="0.49249218661378208"/>
          <c:h val="0.52863772236803741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'Table- genome dataset'!$A$183</c:f>
              <c:strCache>
                <c:ptCount val="1"/>
                <c:pt idx="0">
                  <c:v>High Risk for ADR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</c:spPr>
          <c:invertIfNegative val="0"/>
          <c:cat>
            <c:strRef>
              <c:f>'Table- genome dataset'!$B$182:$D$182</c:f>
              <c:strCache>
                <c:ptCount val="3"/>
                <c:pt idx="0">
                  <c:v>HLA-B*57:01</c:v>
                </c:pt>
                <c:pt idx="1">
                  <c:v>HLA-A*31:01</c:v>
                </c:pt>
                <c:pt idx="2">
                  <c:v>SLCO1B1</c:v>
                </c:pt>
              </c:strCache>
            </c:strRef>
          </c:cat>
          <c:val>
            <c:numRef>
              <c:f>'Table- genome dataset'!$B$183:$D$183</c:f>
              <c:numCache>
                <c:formatCode>General</c:formatCode>
                <c:ptCount val="3"/>
                <c:pt idx="0">
                  <c:v>6</c:v>
                </c:pt>
                <c:pt idx="1">
                  <c:v>10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Table- genome dataset'!$A$184</c:f>
              <c:strCache>
                <c:ptCount val="1"/>
                <c:pt idx="0">
                  <c:v>IntermediateRisk for ADR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cat>
            <c:strRef>
              <c:f>'Table- genome dataset'!$B$182:$D$182</c:f>
              <c:strCache>
                <c:ptCount val="3"/>
                <c:pt idx="0">
                  <c:v>HLA-B*57:01</c:v>
                </c:pt>
                <c:pt idx="1">
                  <c:v>HLA-A*31:01</c:v>
                </c:pt>
                <c:pt idx="2">
                  <c:v>SLCO1B1</c:v>
                </c:pt>
              </c:strCache>
            </c:strRef>
          </c:cat>
          <c:val>
            <c:numRef>
              <c:f>'Table- genome dataset'!$B$184:$D$184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19</c:v>
                </c:pt>
              </c:numCache>
            </c:numRef>
          </c:val>
        </c:ser>
        <c:ser>
          <c:idx val="2"/>
          <c:order val="2"/>
          <c:tx>
            <c:strRef>
              <c:f>'Table- genome dataset'!$A$185</c:f>
              <c:strCache>
                <c:ptCount val="1"/>
                <c:pt idx="0">
                  <c:v>Normal Risk for ADR</c:v>
                </c:pt>
              </c:strCache>
            </c:strRef>
          </c:tx>
          <c:invertIfNegative val="0"/>
          <c:cat>
            <c:strRef>
              <c:f>'Table- genome dataset'!$B$182:$D$182</c:f>
              <c:strCache>
                <c:ptCount val="3"/>
                <c:pt idx="0">
                  <c:v>HLA-B*57:01</c:v>
                </c:pt>
                <c:pt idx="1">
                  <c:v>HLA-A*31:01</c:v>
                </c:pt>
                <c:pt idx="2">
                  <c:v>SLCO1B1</c:v>
                </c:pt>
              </c:strCache>
            </c:strRef>
          </c:cat>
          <c:val>
            <c:numRef>
              <c:f>'Table- genome dataset'!$B$185:$D$185</c:f>
              <c:numCache>
                <c:formatCode>General</c:formatCode>
                <c:ptCount val="3"/>
                <c:pt idx="0">
                  <c:v>92</c:v>
                </c:pt>
                <c:pt idx="1">
                  <c:v>88</c:v>
                </c:pt>
                <c:pt idx="2">
                  <c:v>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405928632"/>
        <c:axId val="405929024"/>
        <c:axId val="0"/>
      </c:bar3DChart>
      <c:catAx>
        <c:axId val="4059286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 b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defRPr>
            </a:pPr>
            <a:endParaRPr lang="en-US"/>
          </a:p>
        </c:txPr>
        <c:crossAx val="405929024"/>
        <c:crosses val="autoZero"/>
        <c:auto val="1"/>
        <c:lblAlgn val="ctr"/>
        <c:lblOffset val="100"/>
        <c:noMultiLvlLbl val="0"/>
      </c:catAx>
      <c:valAx>
        <c:axId val="40592902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defRPr>
            </a:pPr>
            <a:endParaRPr lang="en-US"/>
          </a:p>
        </c:txPr>
        <c:crossAx val="4059286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0513407343791956"/>
          <c:y val="0.38331300449575967"/>
          <c:w val="0.23753610709921119"/>
          <c:h val="0.46301322332345629"/>
        </c:manualLayout>
      </c:layout>
      <c:overlay val="0"/>
      <c:txPr>
        <a:bodyPr/>
        <a:lstStyle/>
        <a:p>
          <a:pPr>
            <a:defRPr sz="80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54813980363837567"/>
          <c:y val="0.15027754117855219"/>
        </c:manualLayout>
      </c:layout>
      <c:overlay val="0"/>
      <c:txPr>
        <a:bodyPr/>
        <a:lstStyle/>
        <a:p>
          <a:pPr>
            <a:defRPr sz="90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defRPr>
          </a:pPr>
          <a:endParaRPr lang="en-US"/>
        </a:p>
      </c:txPr>
    </c:title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0.21105900824896887"/>
          <c:y val="0.34881416849920788"/>
          <c:w val="0.75620289651293593"/>
          <c:h val="0.43970348301056955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'Table- genome dataset'!$C$205</c:f>
              <c:strCache>
                <c:ptCount val="1"/>
                <c:pt idx="0">
                  <c:v>IFNL3</c:v>
                </c:pt>
              </c:strCache>
            </c:strRef>
          </c:tx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</c:spPr>
          </c:dPt>
          <c:cat>
            <c:strRef>
              <c:f>'Table- genome dataset'!$B$206:$B$207</c:f>
              <c:strCache>
                <c:ptCount val="2"/>
                <c:pt idx="0">
                  <c:v>Favorable Response</c:v>
                </c:pt>
                <c:pt idx="1">
                  <c:v>Unfavorable Response</c:v>
                </c:pt>
              </c:strCache>
            </c:strRef>
          </c:cat>
          <c:val>
            <c:numRef>
              <c:f>'Table- genome dataset'!$C$206:$C$207</c:f>
              <c:numCache>
                <c:formatCode>General</c:formatCode>
                <c:ptCount val="2"/>
                <c:pt idx="0">
                  <c:v>51</c:v>
                </c:pt>
                <c:pt idx="1">
                  <c:v>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405929808"/>
        <c:axId val="405930200"/>
        <c:axId val="0"/>
      </c:bar3DChart>
      <c:catAx>
        <c:axId val="4059298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 b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defRPr>
            </a:pPr>
            <a:endParaRPr lang="en-US"/>
          </a:p>
        </c:txPr>
        <c:crossAx val="405930200"/>
        <c:crosses val="autoZero"/>
        <c:auto val="1"/>
        <c:lblAlgn val="ctr"/>
        <c:lblOffset val="100"/>
        <c:noMultiLvlLbl val="0"/>
      </c:catAx>
      <c:valAx>
        <c:axId val="40593020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defRPr>
            </a:pPr>
            <a:endParaRPr lang="en-US"/>
          </a:p>
        </c:txPr>
        <c:crossAx val="4059298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9.4477365587033582E-2"/>
          <c:y val="0.20362625214483848"/>
          <c:w val="0.52214732800179531"/>
          <c:h val="0.41878526043785408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'Table- genome dataset'!$A$162</c:f>
              <c:strCache>
                <c:ptCount val="1"/>
                <c:pt idx="0">
                  <c:v>Ultrarapid Metabolizer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</c:spPr>
          <c:invertIfNegative val="0"/>
          <c:cat>
            <c:strRef>
              <c:f>'Table- genome dataset'!$B$161:$G$161</c:f>
              <c:strCache>
                <c:ptCount val="6"/>
                <c:pt idx="0">
                  <c:v>CYP2C19</c:v>
                </c:pt>
                <c:pt idx="1">
                  <c:v>CYP2C9</c:v>
                </c:pt>
                <c:pt idx="2">
                  <c:v>CYP2D6</c:v>
                </c:pt>
                <c:pt idx="3">
                  <c:v>CYP3A5</c:v>
                </c:pt>
                <c:pt idx="4">
                  <c:v>TPMT</c:v>
                </c:pt>
                <c:pt idx="5">
                  <c:v>DPYD</c:v>
                </c:pt>
              </c:strCache>
            </c:strRef>
          </c:cat>
          <c:val>
            <c:numRef>
              <c:f>'Table- genome dataset'!$B$162:$G$162</c:f>
              <c:numCache>
                <c:formatCode>General</c:formatCode>
                <c:ptCount val="6"/>
                <c:pt idx="0">
                  <c:v>29</c:v>
                </c:pt>
                <c:pt idx="2">
                  <c:v>5</c:v>
                </c:pt>
              </c:numCache>
            </c:numRef>
          </c:val>
        </c:ser>
        <c:ser>
          <c:idx val="1"/>
          <c:order val="1"/>
          <c:tx>
            <c:strRef>
              <c:f>'Table- genome dataset'!$A$163</c:f>
              <c:strCache>
                <c:ptCount val="1"/>
                <c:pt idx="0">
                  <c:v>Extensive Metabolizer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</c:spPr>
          <c:invertIfNegative val="0"/>
          <c:cat>
            <c:strRef>
              <c:f>'Table- genome dataset'!$B$161:$G$161</c:f>
              <c:strCache>
                <c:ptCount val="6"/>
                <c:pt idx="0">
                  <c:v>CYP2C19</c:v>
                </c:pt>
                <c:pt idx="1">
                  <c:v>CYP2C9</c:v>
                </c:pt>
                <c:pt idx="2">
                  <c:v>CYP2D6</c:v>
                </c:pt>
                <c:pt idx="3">
                  <c:v>CYP3A5</c:v>
                </c:pt>
                <c:pt idx="4">
                  <c:v>TPMT</c:v>
                </c:pt>
                <c:pt idx="5">
                  <c:v>DPYD</c:v>
                </c:pt>
              </c:strCache>
            </c:strRef>
          </c:cat>
          <c:val>
            <c:numRef>
              <c:f>'Table- genome dataset'!$B$163:$G$163</c:f>
              <c:numCache>
                <c:formatCode>General</c:formatCode>
                <c:ptCount val="6"/>
                <c:pt idx="0">
                  <c:v>35</c:v>
                </c:pt>
                <c:pt idx="1">
                  <c:v>64</c:v>
                </c:pt>
                <c:pt idx="2">
                  <c:v>83</c:v>
                </c:pt>
                <c:pt idx="3">
                  <c:v>6</c:v>
                </c:pt>
                <c:pt idx="4">
                  <c:v>90</c:v>
                </c:pt>
                <c:pt idx="5">
                  <c:v>98</c:v>
                </c:pt>
              </c:numCache>
            </c:numRef>
          </c:val>
        </c:ser>
        <c:ser>
          <c:idx val="2"/>
          <c:order val="2"/>
          <c:tx>
            <c:strRef>
              <c:f>'Table- genome dataset'!$A$164</c:f>
              <c:strCache>
                <c:ptCount val="1"/>
                <c:pt idx="0">
                  <c:v>Intermediate Metabolizer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cat>
            <c:strRef>
              <c:f>'Table- genome dataset'!$B$161:$G$161</c:f>
              <c:strCache>
                <c:ptCount val="6"/>
                <c:pt idx="0">
                  <c:v>CYP2C19</c:v>
                </c:pt>
                <c:pt idx="1">
                  <c:v>CYP2C9</c:v>
                </c:pt>
                <c:pt idx="2">
                  <c:v>CYP2D6</c:v>
                </c:pt>
                <c:pt idx="3">
                  <c:v>CYP3A5</c:v>
                </c:pt>
                <c:pt idx="4">
                  <c:v>TPMT</c:v>
                </c:pt>
                <c:pt idx="5">
                  <c:v>DPYD</c:v>
                </c:pt>
              </c:strCache>
            </c:strRef>
          </c:cat>
          <c:val>
            <c:numRef>
              <c:f>'Table- genome dataset'!$B$164:$G$164</c:f>
              <c:numCache>
                <c:formatCode>General</c:formatCode>
                <c:ptCount val="6"/>
                <c:pt idx="0">
                  <c:v>31</c:v>
                </c:pt>
                <c:pt idx="1">
                  <c:v>29</c:v>
                </c:pt>
                <c:pt idx="2">
                  <c:v>5</c:v>
                </c:pt>
                <c:pt idx="3">
                  <c:v>18</c:v>
                </c:pt>
                <c:pt idx="4">
                  <c:v>5</c:v>
                </c:pt>
              </c:numCache>
            </c:numRef>
          </c:val>
        </c:ser>
        <c:ser>
          <c:idx val="3"/>
          <c:order val="3"/>
          <c:tx>
            <c:strRef>
              <c:f>'Table- genome dataset'!$A$165</c:f>
              <c:strCache>
                <c:ptCount val="1"/>
                <c:pt idx="0">
                  <c:v>Poor Metabolizer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</c:spPr>
          <c:invertIfNegative val="0"/>
          <c:cat>
            <c:strRef>
              <c:f>'Table- genome dataset'!$B$161:$G$161</c:f>
              <c:strCache>
                <c:ptCount val="6"/>
                <c:pt idx="0">
                  <c:v>CYP2C19</c:v>
                </c:pt>
                <c:pt idx="1">
                  <c:v>CYP2C9</c:v>
                </c:pt>
                <c:pt idx="2">
                  <c:v>CYP2D6</c:v>
                </c:pt>
                <c:pt idx="3">
                  <c:v>CYP3A5</c:v>
                </c:pt>
                <c:pt idx="4">
                  <c:v>TPMT</c:v>
                </c:pt>
                <c:pt idx="5">
                  <c:v>DPYD</c:v>
                </c:pt>
              </c:strCache>
            </c:strRef>
          </c:cat>
          <c:val>
            <c:numRef>
              <c:f>'Table- genome dataset'!$B$165:$G$165</c:f>
              <c:numCache>
                <c:formatCode>General</c:formatCode>
                <c:ptCount val="6"/>
                <c:pt idx="0">
                  <c:v>3</c:v>
                </c:pt>
                <c:pt idx="1">
                  <c:v>5</c:v>
                </c:pt>
                <c:pt idx="2">
                  <c:v>4</c:v>
                </c:pt>
                <c:pt idx="3">
                  <c:v>74</c:v>
                </c:pt>
                <c:pt idx="4">
                  <c:v>3</c:v>
                </c:pt>
                <c:pt idx="5">
                  <c:v>0</c:v>
                </c:pt>
              </c:numCache>
            </c:numRef>
          </c:val>
        </c:ser>
        <c:ser>
          <c:idx val="4"/>
          <c:order val="4"/>
          <c:tx>
            <c:strRef>
              <c:f>'Table- genome dataset'!$A$166</c:f>
              <c:strCache>
                <c:ptCount val="1"/>
                <c:pt idx="0">
                  <c:v>Uncertain</c:v>
                </c:pt>
              </c:strCache>
            </c:strRef>
          </c:tx>
          <c:invertIfNegative val="0"/>
          <c:cat>
            <c:strRef>
              <c:f>'Table- genome dataset'!$B$161:$G$161</c:f>
              <c:strCache>
                <c:ptCount val="6"/>
                <c:pt idx="0">
                  <c:v>CYP2C19</c:v>
                </c:pt>
                <c:pt idx="1">
                  <c:v>CYP2C9</c:v>
                </c:pt>
                <c:pt idx="2">
                  <c:v>CYP2D6</c:v>
                </c:pt>
                <c:pt idx="3">
                  <c:v>CYP3A5</c:v>
                </c:pt>
                <c:pt idx="4">
                  <c:v>TPMT</c:v>
                </c:pt>
                <c:pt idx="5">
                  <c:v>DPYD</c:v>
                </c:pt>
              </c:strCache>
            </c:strRef>
          </c:cat>
          <c:val>
            <c:numRef>
              <c:f>'Table- genome dataset'!$B$166:$G$166</c:f>
              <c:numCache>
                <c:formatCode>General</c:formatCode>
                <c:ptCount val="6"/>
                <c:pt idx="2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405930984"/>
        <c:axId val="405931376"/>
        <c:axId val="0"/>
      </c:bar3DChart>
      <c:catAx>
        <c:axId val="4059309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05931376"/>
        <c:crosses val="autoZero"/>
        <c:auto val="1"/>
        <c:lblAlgn val="ctr"/>
        <c:lblOffset val="100"/>
        <c:noMultiLvlLbl val="0"/>
      </c:catAx>
      <c:valAx>
        <c:axId val="40593137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059309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6337923692220424"/>
          <c:y val="0.21836011325991639"/>
          <c:w val="0.26023734497374224"/>
          <c:h val="0.46749970489390069"/>
        </c:manualLayout>
      </c:layout>
      <c:overlay val="0"/>
      <c:txPr>
        <a:bodyPr/>
        <a:lstStyle/>
        <a:p>
          <a:pPr>
            <a:defRPr sz="8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000" dirty="0"/>
              <a:t>VKORC1 </a:t>
            </a:r>
            <a:r>
              <a:rPr lang="en-US" sz="1000" baseline="0" dirty="0" smtClean="0"/>
              <a:t> </a:t>
            </a:r>
            <a:r>
              <a:rPr lang="en-US" sz="1000" dirty="0" smtClean="0"/>
              <a:t>1639G&gt;A</a:t>
            </a:r>
            <a:endParaRPr lang="en-US" sz="1000" dirty="0"/>
          </a:p>
        </c:rich>
      </c:tx>
      <c:layout>
        <c:manualLayout>
          <c:xMode val="edge"/>
          <c:yMode val="edge"/>
          <c:x val="0.41530315039622456"/>
          <c:y val="9.0336047510165232E-2"/>
        </c:manualLayout>
      </c:layout>
      <c:overlay val="0"/>
    </c:title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0.12119445268933635"/>
          <c:y val="0.31941455516124689"/>
          <c:w val="0.80482931415580705"/>
          <c:h val="0.49036889698198716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'[Chart in Microsoft PowerPoint]Table- genome dataset'!$B$218</c:f>
              <c:strCache>
                <c:ptCount val="1"/>
                <c:pt idx="0">
                  <c:v>VKORC1 Genotype (-1639G&gt;A, rs9923231)</c:v>
                </c:pt>
              </c:strCache>
            </c:strRef>
          </c:tx>
          <c:invertIfNegative val="0"/>
          <c:cat>
            <c:strRef>
              <c:f>'[Chart in Microsoft PowerPoint]Table- genome dataset'!$A$219:$A$221</c:f>
              <c:strCache>
                <c:ptCount val="3"/>
                <c:pt idx="0">
                  <c:v>GG</c:v>
                </c:pt>
                <c:pt idx="1">
                  <c:v>GA</c:v>
                </c:pt>
                <c:pt idx="2">
                  <c:v>AA</c:v>
                </c:pt>
              </c:strCache>
            </c:strRef>
          </c:cat>
          <c:val>
            <c:numRef>
              <c:f>'[Chart in Microsoft PowerPoint]Table- genome dataset'!$B$219:$B$221</c:f>
              <c:numCache>
                <c:formatCode>General</c:formatCode>
                <c:ptCount val="3"/>
                <c:pt idx="0">
                  <c:v>40</c:v>
                </c:pt>
                <c:pt idx="1">
                  <c:v>45</c:v>
                </c:pt>
                <c:pt idx="2">
                  <c:v>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407231448"/>
        <c:axId val="407231840"/>
        <c:axId val="0"/>
      </c:bar3DChart>
      <c:catAx>
        <c:axId val="4072314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07231840"/>
        <c:crosses val="autoZero"/>
        <c:auto val="1"/>
        <c:lblAlgn val="ctr"/>
        <c:lblOffset val="100"/>
        <c:noMultiLvlLbl val="0"/>
      </c:catAx>
      <c:valAx>
        <c:axId val="4072318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072314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727</cdr:x>
      <cdr:y>0.23625</cdr:y>
    </cdr:from>
    <cdr:to>
      <cdr:x>0.29663</cdr:x>
      <cdr:y>0.31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103771" y="648072"/>
          <a:ext cx="792088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800" dirty="0">
              <a:latin typeface="Arial" panose="020B0604020202020204" pitchFamily="34" charset="0"/>
              <a:cs typeface="Arial" panose="020B0604020202020204" pitchFamily="34" charset="0"/>
            </a:rPr>
            <a:t>Patients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025</cdr:x>
      <cdr:y>0.23838</cdr:y>
    </cdr:from>
    <cdr:to>
      <cdr:x>0.36613</cdr:x>
      <cdr:y>0.3181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864096" y="504056"/>
          <a:ext cx="698244" cy="1686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8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rPr>
            <a:t>Patients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3718</cdr:x>
      <cdr:y>0.09539</cdr:y>
    </cdr:from>
    <cdr:to>
      <cdr:x>0.14498</cdr:x>
      <cdr:y>0.17788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310201" y="377965"/>
          <a:ext cx="899474" cy="3268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800" dirty="0">
              <a:latin typeface="Arial" panose="020B0604020202020204" pitchFamily="34" charset="0"/>
              <a:cs typeface="Arial" panose="020B0604020202020204" pitchFamily="34" charset="0"/>
            </a:rPr>
            <a:t>Patients</a:t>
          </a:r>
        </a:p>
      </cdr:txBody>
    </cdr:sp>
  </cdr:relSizeAnchor>
  <cdr:relSizeAnchor xmlns:cdr="http://schemas.openxmlformats.org/drawingml/2006/chartDrawing">
    <cdr:from>
      <cdr:x>0.55479</cdr:x>
      <cdr:y>0.10577</cdr:y>
    </cdr:from>
    <cdr:to>
      <cdr:x>0.66438</cdr:x>
      <cdr:y>0.33654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4629150" y="419101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2178</cdr:x>
      <cdr:y>0.21528</cdr:y>
    </cdr:from>
    <cdr:to>
      <cdr:x>0.25373</cdr:x>
      <cdr:y>0.3725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87532" y="332918"/>
          <a:ext cx="636604" cy="2431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800" dirty="0">
              <a:latin typeface="Arial" panose="020B0604020202020204" pitchFamily="34" charset="0"/>
              <a:cs typeface="Arial" panose="020B0604020202020204" pitchFamily="34" charset="0"/>
            </a:rPr>
            <a:t>Patients</a:t>
          </a: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DA888A-E3D3-4DF2-A287-D646D60F7C7A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D8F7E6-329D-43AD-A09D-F67555555E9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144215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22D0CB-4640-4241-9A0B-3FF1CB3A539D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D27816-A23E-440C-8450-EF4E95072B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11446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: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henotype distribution of interrogated genes with published guidelines </a:t>
            </a:r>
            <a:r>
              <a:rPr lang="en-CA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YP2C19, CYP2C9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CA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YP2D6, CYP3A5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, </a:t>
            </a:r>
            <a:r>
              <a:rPr lang="en-CA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PMT, DPYD, VKORC1, HLA-B*57:01, HLA-A*31:01, SLCO1B1, IFNL3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or all 98 subjects.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CA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D27816-A23E-440C-8450-EF4E95072B79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045721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66494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50959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3555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34365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9296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71921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72000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63244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07574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32609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10509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5FCA9-BF67-45C3-B53B-19D0A8F79F58}" type="datetimeFigureOut">
              <a:rPr lang="en-CA" smtClean="0"/>
              <a:t>24/04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7A13F-3273-42E5-8FFE-DE8DC17A2A8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46462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5385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Figure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5729749"/>
              </p:ext>
            </p:extLst>
          </p:nvPr>
        </p:nvGraphicFramePr>
        <p:xfrm>
          <a:off x="0" y="2996952"/>
          <a:ext cx="5184576" cy="18791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712968" cy="936105"/>
          </a:xfrm>
        </p:spPr>
        <p:txBody>
          <a:bodyPr>
            <a:normAutofit/>
          </a:bodyPr>
          <a:lstStyle/>
          <a:p>
            <a:r>
              <a:rPr lang="en-CA" sz="1800" b="1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Phenotype</a:t>
            </a:r>
            <a:r>
              <a:rPr lang="en-CA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of interrogated genes with published </a:t>
            </a:r>
            <a:r>
              <a:rPr lang="en-CA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uidelines </a:t>
            </a:r>
            <a:r>
              <a:rPr lang="en-CA" sz="1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YP2C19, CYP2C9</a:t>
            </a:r>
            <a:r>
              <a:rPr lang="en-CA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CA" sz="1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YP2D6, CYP3A5</a:t>
            </a:r>
            <a:r>
              <a:rPr lang="en-CA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, </a:t>
            </a:r>
            <a:r>
              <a:rPr lang="en-CA" sz="1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TPMT, DPYD, VKORC1, HLA-B*57:01, HLA-A*31:01, SLCO1B1, IFNL3</a:t>
            </a:r>
            <a:r>
              <a:rPr lang="en-CA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or all 98 subjects</a:t>
            </a:r>
            <a:endParaRPr lang="en-CA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0621321"/>
              </p:ext>
            </p:extLst>
          </p:nvPr>
        </p:nvGraphicFramePr>
        <p:xfrm>
          <a:off x="5292080" y="3212976"/>
          <a:ext cx="3672408" cy="1944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8370332"/>
              </p:ext>
            </p:extLst>
          </p:nvPr>
        </p:nvGraphicFramePr>
        <p:xfrm>
          <a:off x="1267092" y="1340768"/>
          <a:ext cx="6775707" cy="22195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9145437"/>
              </p:ext>
            </p:extLst>
          </p:nvPr>
        </p:nvGraphicFramePr>
        <p:xfrm>
          <a:off x="2051720" y="5129783"/>
          <a:ext cx="4824536" cy="1546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5247539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15</TotalTime>
  <Words>80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 Unicode MS</vt:lpstr>
      <vt:lpstr>Arial</vt:lpstr>
      <vt:lpstr>Calibri</vt:lpstr>
      <vt:lpstr>Office Theme</vt:lpstr>
      <vt:lpstr>Phenotype distribution of interrogated genes with published guidelines CYP2C19, CYP2C9, CYP2D6, CYP3A5 , TPMT, DPYD, VKORC1, HLA-B*57:01, HLA-A*31:01, SLCO1B1, IFNL3 for all 98 subject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Iris Cohn</dc:creator>
  <cp:lastModifiedBy>Iris Cohn</cp:lastModifiedBy>
  <cp:revision>242</cp:revision>
  <dcterms:created xsi:type="dcterms:W3CDTF">2015-12-07T17:44:27Z</dcterms:created>
  <dcterms:modified xsi:type="dcterms:W3CDTF">2017-04-24T17:19:52Z</dcterms:modified>
</cp:coreProperties>
</file>